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66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E7EAED"/>
    <a:srgbClr val="CCD2D8"/>
    <a:srgbClr val="156082"/>
    <a:srgbClr val="BAD9E4"/>
    <a:srgbClr val="94C3D4"/>
    <a:srgbClr val="1D85B3"/>
    <a:srgbClr val="DEDE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45" d="100"/>
          <a:sy n="45" d="100"/>
        </p:scale>
        <p:origin x="13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jafi, Allison" userId="0304a55d-1748-4b32-895c-375cbdec2d3f" providerId="ADAL" clId="{FAB1605A-31FE-4E95-98E4-51DC469C8FF1}"/>
    <pc:docChg chg="delSld">
      <pc:chgData name="Najafi, Allison" userId="0304a55d-1748-4b32-895c-375cbdec2d3f" providerId="ADAL" clId="{FAB1605A-31FE-4E95-98E4-51DC469C8FF1}" dt="2025-01-27T21:33:24.644" v="8" actId="47"/>
      <pc:docMkLst>
        <pc:docMk/>
      </pc:docMkLst>
      <pc:sldChg chg="del">
        <pc:chgData name="Najafi, Allison" userId="0304a55d-1748-4b32-895c-375cbdec2d3f" providerId="ADAL" clId="{FAB1605A-31FE-4E95-98E4-51DC469C8FF1}" dt="2025-01-27T21:33:19.007" v="0" actId="47"/>
        <pc:sldMkLst>
          <pc:docMk/>
          <pc:sldMk cId="2725620228" sldId="256"/>
        </pc:sldMkLst>
      </pc:sldChg>
      <pc:sldChg chg="del">
        <pc:chgData name="Najafi, Allison" userId="0304a55d-1748-4b32-895c-375cbdec2d3f" providerId="ADAL" clId="{FAB1605A-31FE-4E95-98E4-51DC469C8FF1}" dt="2025-01-27T21:33:19.350" v="1" actId="47"/>
        <pc:sldMkLst>
          <pc:docMk/>
          <pc:sldMk cId="3569514842" sldId="257"/>
        </pc:sldMkLst>
      </pc:sldChg>
      <pc:sldChg chg="del">
        <pc:chgData name="Najafi, Allison" userId="0304a55d-1748-4b32-895c-375cbdec2d3f" providerId="ADAL" clId="{FAB1605A-31FE-4E95-98E4-51DC469C8FF1}" dt="2025-01-27T21:33:20.636" v="3" actId="47"/>
        <pc:sldMkLst>
          <pc:docMk/>
          <pc:sldMk cId="2505032853" sldId="258"/>
        </pc:sldMkLst>
      </pc:sldChg>
      <pc:sldChg chg="del">
        <pc:chgData name="Najafi, Allison" userId="0304a55d-1748-4b32-895c-375cbdec2d3f" providerId="ADAL" clId="{FAB1605A-31FE-4E95-98E4-51DC469C8FF1}" dt="2025-01-27T21:33:23.546" v="6" actId="47"/>
        <pc:sldMkLst>
          <pc:docMk/>
          <pc:sldMk cId="2305346892" sldId="259"/>
        </pc:sldMkLst>
      </pc:sldChg>
      <pc:sldChg chg="del">
        <pc:chgData name="Najafi, Allison" userId="0304a55d-1748-4b32-895c-375cbdec2d3f" providerId="ADAL" clId="{FAB1605A-31FE-4E95-98E4-51DC469C8FF1}" dt="2025-01-27T21:33:19.737" v="2" actId="47"/>
        <pc:sldMkLst>
          <pc:docMk/>
          <pc:sldMk cId="2192517872" sldId="260"/>
        </pc:sldMkLst>
      </pc:sldChg>
      <pc:sldChg chg="del">
        <pc:chgData name="Najafi, Allison" userId="0304a55d-1748-4b32-895c-375cbdec2d3f" providerId="ADAL" clId="{FAB1605A-31FE-4E95-98E4-51DC469C8FF1}" dt="2025-01-27T21:33:22.576" v="4" actId="47"/>
        <pc:sldMkLst>
          <pc:docMk/>
          <pc:sldMk cId="3507118384" sldId="262"/>
        </pc:sldMkLst>
      </pc:sldChg>
      <pc:sldChg chg="del">
        <pc:chgData name="Najafi, Allison" userId="0304a55d-1748-4b32-895c-375cbdec2d3f" providerId="ADAL" clId="{FAB1605A-31FE-4E95-98E4-51DC469C8FF1}" dt="2025-01-27T21:33:23.087" v="5" actId="47"/>
        <pc:sldMkLst>
          <pc:docMk/>
          <pc:sldMk cId="3515496556" sldId="263"/>
        </pc:sldMkLst>
      </pc:sldChg>
      <pc:sldChg chg="del">
        <pc:chgData name="Najafi, Allison" userId="0304a55d-1748-4b32-895c-375cbdec2d3f" providerId="ADAL" clId="{FAB1605A-31FE-4E95-98E4-51DC469C8FF1}" dt="2025-01-27T21:33:24.001" v="7" actId="47"/>
        <pc:sldMkLst>
          <pc:docMk/>
          <pc:sldMk cId="2264077816" sldId="264"/>
        </pc:sldMkLst>
      </pc:sldChg>
      <pc:sldChg chg="del">
        <pc:chgData name="Najafi, Allison" userId="0304a55d-1748-4b32-895c-375cbdec2d3f" providerId="ADAL" clId="{FAB1605A-31FE-4E95-98E4-51DC469C8FF1}" dt="2025-01-27T21:33:24.644" v="8" actId="47"/>
        <pc:sldMkLst>
          <pc:docMk/>
          <pc:sldMk cId="639073537" sldId="26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4D3A9-35B5-48F4-9529-65B199B619BB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1A9764-E4BA-4EB9-9AD5-E4A142AF8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23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6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6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73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76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26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0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368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276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53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391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730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0E17E5-8E71-45BA-9800-8123D4E470C7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61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C143159-9085-22F2-222F-E8F18C8674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4816017"/>
              </p:ext>
            </p:extLst>
          </p:nvPr>
        </p:nvGraphicFramePr>
        <p:xfrm>
          <a:off x="384048" y="291093"/>
          <a:ext cx="5422392" cy="589151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11715">
                  <a:extLst>
                    <a:ext uri="{9D8B030D-6E8A-4147-A177-3AD203B41FA5}">
                      <a16:colId xmlns:a16="http://schemas.microsoft.com/office/drawing/2014/main" val="3345719812"/>
                    </a:ext>
                  </a:extLst>
                </a:gridCol>
                <a:gridCol w="1038514">
                  <a:extLst>
                    <a:ext uri="{9D8B030D-6E8A-4147-A177-3AD203B41FA5}">
                      <a16:colId xmlns:a16="http://schemas.microsoft.com/office/drawing/2014/main" val="713685034"/>
                    </a:ext>
                  </a:extLst>
                </a:gridCol>
                <a:gridCol w="1216415">
                  <a:extLst>
                    <a:ext uri="{9D8B030D-6E8A-4147-A177-3AD203B41FA5}">
                      <a16:colId xmlns:a16="http://schemas.microsoft.com/office/drawing/2014/main" val="3629864832"/>
                    </a:ext>
                  </a:extLst>
                </a:gridCol>
                <a:gridCol w="1355748">
                  <a:extLst>
                    <a:ext uri="{9D8B030D-6E8A-4147-A177-3AD203B41FA5}">
                      <a16:colId xmlns:a16="http://schemas.microsoft.com/office/drawing/2014/main" val="1988582535"/>
                    </a:ext>
                  </a:extLst>
                </a:gridCol>
              </a:tblGrid>
              <a:tr h="263878"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Supplemental Table 3. Alpha-blocker use through 1 and 5 years post-BPH procedur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8694590"/>
                  </a:ext>
                </a:extLst>
              </a:tr>
              <a:tr h="26387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TURP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PVP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PUL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5608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5106160"/>
                  </a:ext>
                </a:extLst>
              </a:tr>
              <a:tr h="26387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erioperative Use Only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9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8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06374921"/>
                  </a:ext>
                </a:extLst>
              </a:tr>
              <a:tr h="14989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6.6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.1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0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2609042"/>
                  </a:ext>
                </a:extLst>
              </a:tr>
              <a:tr h="249218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-year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4527623"/>
                  </a:ext>
                </a:extLst>
              </a:tr>
              <a:tr h="33882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ontinued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med history prior to procedure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.2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.4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2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40171904"/>
                  </a:ext>
                </a:extLst>
              </a:tr>
              <a:tr h="14989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.1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.5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4.9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7986857"/>
                  </a:ext>
                </a:extLst>
              </a:tr>
              <a:tr h="33882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e novo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no med history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7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8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4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1777157"/>
                  </a:ext>
                </a:extLst>
              </a:tr>
              <a:tr h="14989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1.8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1.2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6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32032419"/>
                  </a:ext>
                </a:extLst>
              </a:tr>
              <a:tr h="26387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-year total rat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4.9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.5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4263761"/>
                  </a:ext>
                </a:extLst>
              </a:tr>
              <a:tr h="149897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.3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7.4%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5.2%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7720667"/>
                  </a:ext>
                </a:extLst>
              </a:tr>
              <a:tr h="249218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-yea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7538241"/>
                  </a:ext>
                </a:extLst>
              </a:tr>
              <a:tr h="33882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ontinued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med history prior to procedure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.6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.9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7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7113593"/>
                  </a:ext>
                </a:extLst>
              </a:tr>
              <a:tr h="14989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7.4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9.9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4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9602889"/>
                  </a:ext>
                </a:extLst>
              </a:tr>
              <a:tr h="33882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e novo use 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no med history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7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2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6804684"/>
                  </a:ext>
                </a:extLst>
              </a:tr>
              <a:tr h="14989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1.3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4.2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0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5025850"/>
                  </a:ext>
                </a:extLst>
              </a:tr>
              <a:tr h="24921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-year total rat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8.3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8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8.9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2498095"/>
                  </a:ext>
                </a:extLst>
              </a:tr>
              <a:tr h="149897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.3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.8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5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69804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58034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9037ea0-f10b-40ae-9076-89db66a894de">
      <Terms xmlns="http://schemas.microsoft.com/office/infopath/2007/PartnerControls"/>
    </lcf76f155ced4ddcb4097134ff3c332f>
    <TaxCatchAll xmlns="08c674ba-5fce-4f45-b52a-53002431429b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5E9A582350B14998924DDC17E51716" ma:contentTypeVersion="18" ma:contentTypeDescription="Create a new document." ma:contentTypeScope="" ma:versionID="96056b74b4a12ad6a139844a6ffbd153">
  <xsd:schema xmlns:xsd="http://www.w3.org/2001/XMLSchema" xmlns:xs="http://www.w3.org/2001/XMLSchema" xmlns:p="http://schemas.microsoft.com/office/2006/metadata/properties" xmlns:ns2="19037ea0-f10b-40ae-9076-89db66a894de" xmlns:ns3="08c674ba-5fce-4f45-b52a-53002431429b" targetNamespace="http://schemas.microsoft.com/office/2006/metadata/properties" ma:root="true" ma:fieldsID="32741ccdb4800b1dc5dcd9d685f98680" ns2:_="" ns3:_="">
    <xsd:import namespace="19037ea0-f10b-40ae-9076-89db66a894de"/>
    <xsd:import namespace="08c674ba-5fce-4f45-b52a-5300243142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037ea0-f10b-40ae-9076-89db66a894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description="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94f6455-2e7a-42ed-804e-66c7398b921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c674ba-5fce-4f45-b52a-53002431429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64d7f076-b0d0-40ce-a473-c236f2d5f48b}" ma:internalName="TaxCatchAll" ma:showField="CatchAllData" ma:web="08c674ba-5fce-4f45-b52a-53002431429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1D81719-BA39-4D73-878A-4271EEAE4D7D}">
  <ds:schemaRefs>
    <ds:schemaRef ds:uri="http://schemas.microsoft.com/office/2006/metadata/properties"/>
    <ds:schemaRef ds:uri="http://schemas.microsoft.com/office/infopath/2007/PartnerControls"/>
    <ds:schemaRef ds:uri="19037ea0-f10b-40ae-9076-89db66a894de"/>
    <ds:schemaRef ds:uri="08c674ba-5fce-4f45-b52a-53002431429b"/>
  </ds:schemaRefs>
</ds:datastoreItem>
</file>

<file path=customXml/itemProps2.xml><?xml version="1.0" encoding="utf-8"?>
<ds:datastoreItem xmlns:ds="http://schemas.openxmlformats.org/officeDocument/2006/customXml" ds:itemID="{2B79E374-0ED2-4DBF-A568-5A8D1D62EC3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22E1F52-6CE7-4F17-B1D5-CC492C53723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037ea0-f10b-40ae-9076-89db66a894de"/>
    <ds:schemaRef ds:uri="08c674ba-5fce-4f45-b52a-53002431429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83</TotalTime>
  <Words>195</Words>
  <Application>Microsoft Office PowerPoint</Application>
  <PresentationFormat>Letter Paper (8.5x11 in)</PresentationFormat>
  <Paragraphs>6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jafi, Allison</dc:creator>
  <cp:lastModifiedBy>Najafi, Allison</cp:lastModifiedBy>
  <cp:revision>2</cp:revision>
  <dcterms:created xsi:type="dcterms:W3CDTF">2024-08-09T21:05:57Z</dcterms:created>
  <dcterms:modified xsi:type="dcterms:W3CDTF">2025-01-27T21:33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5E9A582350B14998924DDC17E51716</vt:lpwstr>
  </property>
  <property fmtid="{D5CDD505-2E9C-101B-9397-08002B2CF9AE}" pid="3" name="MediaServiceImageTags">
    <vt:lpwstr/>
  </property>
</Properties>
</file>